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0" r:id="rId3"/>
    <p:sldId id="261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8" d="100"/>
          <a:sy n="118" d="100"/>
        </p:scale>
        <p:origin x="240" y="3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l-NL"/>
              <a:t>Klik om de stijl te bewerken</a:t>
            </a:r>
            <a:endParaRPr lang="en-US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l-NL"/>
              <a:t>Klik om de ondertitelstijl van het model te bewerken</a:t>
            </a:r>
            <a:endParaRPr lang="en-US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E0E8B-051A-40D9-B06D-81B48D12B7A1}" type="datetimeFigureOut">
              <a:rPr lang="en-US" smtClean="0"/>
              <a:t>8/24/25</a:t>
            </a:fld>
            <a:endParaRPr lang="en-US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85C94-80AF-4797-805D-A01127854E4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76469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  <a:endParaRPr lang="en-US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E0E8B-051A-40D9-B06D-81B48D12B7A1}" type="datetimeFigureOut">
              <a:rPr lang="en-US" smtClean="0"/>
              <a:t>8/24/25</a:t>
            </a:fld>
            <a:endParaRPr lang="en-US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85C94-80AF-4797-805D-A01127854E4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56444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l-NL"/>
              <a:t>Klik om de stijl te bewerken</a:t>
            </a:r>
            <a:endParaRPr lang="en-US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E0E8B-051A-40D9-B06D-81B48D12B7A1}" type="datetimeFigureOut">
              <a:rPr lang="en-US" smtClean="0"/>
              <a:t>8/24/25</a:t>
            </a:fld>
            <a:endParaRPr lang="en-US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85C94-80AF-4797-805D-A01127854E4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92069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  <a:endParaRPr lang="en-US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E0E8B-051A-40D9-B06D-81B48D12B7A1}" type="datetimeFigureOut">
              <a:rPr lang="en-US" smtClean="0"/>
              <a:t>8/24/25</a:t>
            </a:fld>
            <a:endParaRPr lang="en-US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85C94-80AF-4797-805D-A01127854E4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53493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l-NL"/>
              <a:t>Klik om de stijl te bewerken</a:t>
            </a:r>
            <a:endParaRPr lang="en-US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E0E8B-051A-40D9-B06D-81B48D12B7A1}" type="datetimeFigureOut">
              <a:rPr lang="en-US" smtClean="0"/>
              <a:t>8/24/25</a:t>
            </a:fld>
            <a:endParaRPr lang="en-US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85C94-80AF-4797-805D-A01127854E4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56337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  <a:endParaRPr lang="en-US"/>
          </a:p>
        </p:txBody>
      </p:sp>
      <p:sp>
        <p:nvSpPr>
          <p:cNvPr id="3" name="Tijdelijke aanduiding voor inhoud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E0E8B-051A-40D9-B06D-81B48D12B7A1}" type="datetimeFigureOut">
              <a:rPr lang="en-US" smtClean="0"/>
              <a:t>8/24/25</a:t>
            </a:fld>
            <a:endParaRPr lang="en-US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85C94-80AF-4797-805D-A01127854E4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33422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l-NL"/>
              <a:t>Klik om de stijl te bewerken</a:t>
            </a:r>
            <a:endParaRPr lang="en-US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5" name="Tijdelijke aanduiding voor tekst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6" name="Tijdelijke aanduiding voor inhoud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7" name="Tijdelijke aanduiding voo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E0E8B-051A-40D9-B06D-81B48D12B7A1}" type="datetimeFigureOut">
              <a:rPr lang="en-US" smtClean="0"/>
              <a:t>8/24/25</a:t>
            </a:fld>
            <a:endParaRPr lang="en-US"/>
          </a:p>
        </p:txBody>
      </p:sp>
      <p:sp>
        <p:nvSpPr>
          <p:cNvPr id="8" name="Tijdelijke aanduiding voor voet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Tijdelijke aanduiding voor dia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85C94-80AF-4797-805D-A01127854E4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18225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  <a:endParaRPr lang="en-US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E0E8B-051A-40D9-B06D-81B48D12B7A1}" type="datetimeFigureOut">
              <a:rPr lang="en-US" smtClean="0"/>
              <a:t>8/24/25</a:t>
            </a:fld>
            <a:endParaRPr lang="en-US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85C94-80AF-4797-805D-A01127854E4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682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E0E8B-051A-40D9-B06D-81B48D12B7A1}" type="datetimeFigureOut">
              <a:rPr lang="en-US" smtClean="0"/>
              <a:t>8/24/25</a:t>
            </a:fld>
            <a:endParaRPr lang="en-US"/>
          </a:p>
        </p:txBody>
      </p:sp>
      <p:sp>
        <p:nvSpPr>
          <p:cNvPr id="3" name="Tijdelijke aanduiding voor voet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85C94-80AF-4797-805D-A01127854E4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05123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de stijl te bewerken</a:t>
            </a:r>
            <a:endParaRPr lang="en-US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E0E8B-051A-40D9-B06D-81B48D12B7A1}" type="datetimeFigureOut">
              <a:rPr lang="en-US" smtClean="0"/>
              <a:t>8/24/25</a:t>
            </a:fld>
            <a:endParaRPr lang="en-US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85C94-80AF-4797-805D-A01127854E4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48349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de stijl te bewerken</a:t>
            </a:r>
            <a:endParaRPr lang="en-US"/>
          </a:p>
        </p:txBody>
      </p:sp>
      <p:sp>
        <p:nvSpPr>
          <p:cNvPr id="3" name="Tijdelijke aanduiding voor afbeelding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E0E8B-051A-40D9-B06D-81B48D12B7A1}" type="datetimeFigureOut">
              <a:rPr lang="en-US" smtClean="0"/>
              <a:t>8/24/25</a:t>
            </a:fld>
            <a:endParaRPr lang="en-US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85C94-80AF-4797-805D-A01127854E4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12961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/>
              <a:t>Klik om de stijl te bewerken</a:t>
            </a:r>
            <a:endParaRPr lang="en-US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CE0E8B-051A-40D9-B06D-81B48D12B7A1}" type="datetimeFigureOut">
              <a:rPr lang="en-US" smtClean="0"/>
              <a:t>8/24/25</a:t>
            </a:fld>
            <a:endParaRPr lang="en-US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285C94-80AF-4797-805D-A01127854E4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51113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.png"/><Relationship Id="rId3" Type="http://schemas.microsoft.com/office/2007/relationships/media" Target="../media/media2.mp4"/><Relationship Id="rId7" Type="http://schemas.openxmlformats.org/officeDocument/2006/relationships/slideLayout" Target="../slideLayouts/slideLayout2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video" Target="../media/media3.mp4"/><Relationship Id="rId5" Type="http://schemas.microsoft.com/office/2007/relationships/media" Target="../media/media3.mp4"/><Relationship Id="rId10" Type="http://schemas.openxmlformats.org/officeDocument/2006/relationships/image" Target="../media/image3.png"/><Relationship Id="rId4" Type="http://schemas.openxmlformats.org/officeDocument/2006/relationships/video" Target="../media/media2.mp4"/><Relationship Id="rId9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media" Target="../media/media5.mp4"/><Relationship Id="rId7" Type="http://schemas.openxmlformats.org/officeDocument/2006/relationships/image" Target="../media/image5.png"/><Relationship Id="rId2" Type="http://schemas.openxmlformats.org/officeDocument/2006/relationships/video" Target="../media/media4.mp4"/><Relationship Id="rId1" Type="http://schemas.microsoft.com/office/2007/relationships/media" Target="../media/media4.mp4"/><Relationship Id="rId6" Type="http://schemas.openxmlformats.org/officeDocument/2006/relationships/image" Target="../media/image4.png"/><Relationship Id="rId5" Type="http://schemas.openxmlformats.org/officeDocument/2006/relationships/slideLayout" Target="../slideLayouts/slideLayout2.xml"/><Relationship Id="rId4" Type="http://schemas.openxmlformats.org/officeDocument/2006/relationships/video" Target="../media/media5.mp4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nl-NL" dirty="0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nl-NL" dirty="0" err="1">
                <a:latin typeface="Arial" panose="020B0604020202020204" pitchFamily="34" charset="0"/>
                <a:cs typeface="Arial" panose="020B0604020202020204" pitchFamily="34" charset="0"/>
              </a:rPr>
              <a:t>material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Movies 1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085648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dirty="0">
                <a:latin typeface="Arial" panose="020B0604020202020204" pitchFamily="34" charset="0"/>
                <a:cs typeface="Arial" panose="020B0604020202020204" pitchFamily="34" charset="0"/>
              </a:rPr>
              <a:t>Case 1 - CMR cine imaging 05-2021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838200" y="1825624"/>
            <a:ext cx="10515600" cy="4957109"/>
          </a:xfrm>
        </p:spPr>
        <p:txBody>
          <a:bodyPr>
            <a:normAutofit fontScale="92500" lnSpcReduction="20000"/>
          </a:bodyPr>
          <a:lstStyle/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r>
              <a:rPr lang="en-US" dirty="0"/>
              <a:t>GE Healthcare 1.5T CMR scanner. Cine, LGE, T1 pre- and post contrast and T2 mapping. Gadolinium contrast dose 0.2mmol/kg</a:t>
            </a:r>
          </a:p>
        </p:txBody>
      </p:sp>
      <p:pic>
        <p:nvPicPr>
          <p:cNvPr id="4" name="604F81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8"/>
          <a:stretch>
            <a:fillRect/>
          </a:stretch>
        </p:blipFill>
        <p:spPr>
          <a:xfrm>
            <a:off x="8335747" y="1399055"/>
            <a:ext cx="3445933" cy="4349749"/>
          </a:xfrm>
          <a:prstGeom prst="rect">
            <a:avLst/>
          </a:prstGeom>
        </p:spPr>
      </p:pic>
      <p:pic>
        <p:nvPicPr>
          <p:cNvPr id="5" name="F641F99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9"/>
          <a:stretch>
            <a:fillRect/>
          </a:stretch>
        </p:blipFill>
        <p:spPr>
          <a:xfrm>
            <a:off x="4337771" y="1399055"/>
            <a:ext cx="3445001" cy="4349749"/>
          </a:xfrm>
          <a:prstGeom prst="rect">
            <a:avLst/>
          </a:prstGeom>
        </p:spPr>
      </p:pic>
      <p:pic>
        <p:nvPicPr>
          <p:cNvPr id="6" name="6D4250E">
            <a:hlinkClick r:id="" action="ppaction://media"/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10"/>
          <a:stretch>
            <a:fillRect/>
          </a:stretch>
        </p:blipFill>
        <p:spPr>
          <a:xfrm>
            <a:off x="339796" y="1399055"/>
            <a:ext cx="3445001" cy="43497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0104993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8480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" fill="hold">
                            <p:stCondLst>
                              <p:cond delay="8480"/>
                            </p:stCondLst>
                            <p:childTnLst>
                              <p:par>
                                <p:cTn id="8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9" dur="12545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0" fill="hold">
                            <p:stCondLst>
                              <p:cond delay="21025"/>
                            </p:stCondLst>
                            <p:childTnLst>
                              <p:par>
                                <p:cTn id="11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2" dur="12933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13" restart="whenNotActive" fill="hold" evtFilter="cancelBubble" nodeType="interactiveSeq">
                <p:stCondLst>
                  <p:cond evt="onClick" delay="0">
                    <p:tgtEl>
                      <p:spTgt spid="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4" fill="hold">
                      <p:stCondLst>
                        <p:cond delay="0"/>
                      </p:stCondLst>
                      <p:childTnLst>
                        <p:par>
                          <p:cTn id="15" fill="hold">
                            <p:stCondLst>
                              <p:cond delay="0"/>
                            </p:stCondLst>
                            <p:childTnLst>
                              <p:par>
                                <p:cTn id="16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7" dur="8480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6"/>
                  </p:tgtEl>
                </p:cond>
              </p:nextCondLst>
            </p:seq>
            <p:seq concurrent="1" nextAc="seek">
              <p:cTn id="18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9" fill="hold">
                      <p:stCondLst>
                        <p:cond delay="0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2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2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seq concurrent="1" nextAc="seek">
              <p:cTn id="23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24" fill="hold">
                      <p:stCondLst>
                        <p:cond delay="0"/>
                      </p:stCondLst>
                      <p:childTnLst>
                        <p:par>
                          <p:cTn id="25" fill="hold">
                            <p:stCondLst>
                              <p:cond delay="0"/>
                            </p:stCondLst>
                            <p:childTnLst>
                              <p:par>
                                <p:cTn id="26" presetID="2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7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 mute="1">
                <p:cTn id="28" fill="hold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  <p:video>
              <p:cMediaNode vol="80000" mute="1">
                <p:cTn id="29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  <p:video>
              <p:cMediaNode vol="80000" mute="1">
                <p:cTn id="30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ase 2 - CMR cine imaging 08-2020</a:t>
            </a:r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838200" y="1825625"/>
            <a:ext cx="10515600" cy="4825546"/>
          </a:xfrm>
        </p:spPr>
        <p:txBody>
          <a:bodyPr>
            <a:normAutofit/>
          </a:bodyPr>
          <a:lstStyle/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r>
              <a:rPr lang="en-US" dirty="0"/>
              <a:t>Philips 1.5T CMR scanner. Cine, LGE. Gadolinium contrast dose 0,5 mmol/ml. 30 ml per patient</a:t>
            </a:r>
          </a:p>
          <a:p>
            <a:endParaRPr lang="en-US" dirty="0"/>
          </a:p>
        </p:txBody>
      </p:sp>
      <p:pic>
        <p:nvPicPr>
          <p:cNvPr id="4" name="B2CF750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6222693" y="1847272"/>
            <a:ext cx="4901935" cy="3523789"/>
          </a:xfrm>
          <a:prstGeom prst="rect">
            <a:avLst/>
          </a:prstGeom>
        </p:spPr>
      </p:pic>
      <p:pic>
        <p:nvPicPr>
          <p:cNvPr id="5" name="8FCBF56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1144012" y="1847272"/>
            <a:ext cx="4282273" cy="35237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4012049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8568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  <p:par>
                                <p:cTn id="7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8" dur="8395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9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video>
              <p:cMediaNode vol="80000">
                <p:cTn id="10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Kantoorthema">
  <a:themeElements>
    <a:clrScheme name="Kantoor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antoor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9</TotalTime>
  <Words>64</Words>
  <Application>Microsoft Macintosh PowerPoint</Application>
  <PresentationFormat>Breedbeeld</PresentationFormat>
  <Paragraphs>23</Paragraphs>
  <Slides>3</Slides>
  <Notes>0</Notes>
  <HiddenSlides>0</HiddenSlides>
  <MMClips>5</MMClips>
  <ScaleCrop>false</ScaleCrop>
  <HeadingPairs>
    <vt:vector size="6" baseType="variant">
      <vt:variant>
        <vt:lpstr>Gebruikte lettertypen</vt:lpstr>
      </vt:variant>
      <vt:variant>
        <vt:i4>3</vt:i4>
      </vt:variant>
      <vt:variant>
        <vt:lpstr>Thema</vt:lpstr>
      </vt:variant>
      <vt:variant>
        <vt:i4>1</vt:i4>
      </vt:variant>
      <vt:variant>
        <vt:lpstr>Diatitel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Kantoorthema</vt:lpstr>
      <vt:lpstr>Supplemental material</vt:lpstr>
      <vt:lpstr>Case 1 - CMR cine imaging 05-2021</vt:lpstr>
      <vt:lpstr>Case 2 - CMR cine imaging 08-2020</vt:lpstr>
    </vt:vector>
  </TitlesOfParts>
  <Manager/>
  <Company>Erasmus MC</Company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iger_supplemental_movies_1</dc:title>
  <dc:subject/>
  <dc:creator>J.M.I.H. Gho</dc:creator>
  <cp:keywords/>
  <dc:description/>
  <cp:lastModifiedBy>Ing Han Gho</cp:lastModifiedBy>
  <cp:revision>47</cp:revision>
  <dcterms:created xsi:type="dcterms:W3CDTF">2023-09-02T17:35:35Z</dcterms:created>
  <dcterms:modified xsi:type="dcterms:W3CDTF">2025-08-24T21:58:27Z</dcterms:modified>
  <cp:category/>
</cp:coreProperties>
</file>